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05613" cy="9944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377" y="-124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10%20cases%20write-up\Recalculated%20plans%20Eclipse%20V13.7%20and%20Monte%20carlo\XRT%20V%20PBT%2022.1.20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CS HFU OR V NOR'!$B$1:$B$2</c:f>
              <c:strCache>
                <c:ptCount val="2"/>
                <c:pt idx="0">
                  <c:v>Case 1</c:v>
                </c:pt>
                <c:pt idx="1">
                  <c:v>No I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WCS HFU OR V NOR'!$A$3:$A$20</c:f>
              <c:strCache>
                <c:ptCount val="18"/>
                <c:pt idx="0">
                  <c:v>CTV D95 (%)</c:v>
                </c:pt>
                <c:pt idx="1">
                  <c:v>Lung V5 (%)</c:v>
                </c:pt>
                <c:pt idx="2">
                  <c:v>Lung V10 (%)</c:v>
                </c:pt>
                <c:pt idx="3">
                  <c:v>Lung V20 (%)</c:v>
                </c:pt>
                <c:pt idx="4">
                  <c:v>Mean lung Dose (Gy)</c:v>
                </c:pt>
                <c:pt idx="5">
                  <c:v>Contralateral lung V5 (Gy)</c:v>
                </c:pt>
                <c:pt idx="6">
                  <c:v>Contralateral lung V10 (Gy)</c:v>
                </c:pt>
                <c:pt idx="7">
                  <c:v>Contralateral lung V20 (Gy)</c:v>
                </c:pt>
                <c:pt idx="8">
                  <c:v>Heart V5 (%)</c:v>
                </c:pt>
                <c:pt idx="9">
                  <c:v>Heart V10 (%)</c:v>
                </c:pt>
                <c:pt idx="10">
                  <c:v>Heart V20 (%)</c:v>
                </c:pt>
                <c:pt idx="11">
                  <c:v>Heart V30 (%)</c:v>
                </c:pt>
                <c:pt idx="12">
                  <c:v>Heart V40 (%)</c:v>
                </c:pt>
                <c:pt idx="13">
                  <c:v>Mean heart dose (Gy)</c:v>
                </c:pt>
                <c:pt idx="14">
                  <c:v>Oesophagus V35 (%)</c:v>
                </c:pt>
                <c:pt idx="15">
                  <c:v>SC Dmax (Gy) (1cc)  </c:v>
                </c:pt>
                <c:pt idx="16">
                  <c:v>BP Dmax (Gy) (1cc)</c:v>
                </c:pt>
                <c:pt idx="17">
                  <c:v>Mean TV dose (Gy)</c:v>
                </c:pt>
              </c:strCache>
            </c:strRef>
          </c:cat>
          <c:val>
            <c:numRef>
              <c:f>'WCS HFU OR V NOR'!$B$3:$B$20</c:f>
              <c:numCache>
                <c:formatCode>0.00</c:formatCode>
                <c:ptCount val="18"/>
                <c:pt idx="0">
                  <c:v>96.34</c:v>
                </c:pt>
                <c:pt idx="1">
                  <c:v>21.14</c:v>
                </c:pt>
                <c:pt idx="2" formatCode="General">
                  <c:v>18.59</c:v>
                </c:pt>
                <c:pt idx="3">
                  <c:v>15.12</c:v>
                </c:pt>
                <c:pt idx="4">
                  <c:v>6.74</c:v>
                </c:pt>
                <c:pt idx="5">
                  <c:v>0.2</c:v>
                </c:pt>
                <c:pt idx="6">
                  <c:v>0</c:v>
                </c:pt>
                <c:pt idx="7">
                  <c:v>0</c:v>
                </c:pt>
                <c:pt idx="8">
                  <c:v>15.77</c:v>
                </c:pt>
                <c:pt idx="9">
                  <c:v>12.72</c:v>
                </c:pt>
                <c:pt idx="10">
                  <c:v>9.39</c:v>
                </c:pt>
                <c:pt idx="11">
                  <c:v>7.22</c:v>
                </c:pt>
                <c:pt idx="12">
                  <c:v>5.46</c:v>
                </c:pt>
                <c:pt idx="13">
                  <c:v>3.66</c:v>
                </c:pt>
                <c:pt idx="14" formatCode="General">
                  <c:v>14.2</c:v>
                </c:pt>
                <c:pt idx="15">
                  <c:v>45.05</c:v>
                </c:pt>
                <c:pt idx="16">
                  <c:v>64.790000000000006</c:v>
                </c:pt>
                <c:pt idx="17" formatCode="General">
                  <c:v>7.44</c:v>
                </c:pt>
              </c:numCache>
            </c:numRef>
          </c:val>
        </c:ser>
        <c:ser>
          <c:idx val="1"/>
          <c:order val="1"/>
          <c:tx>
            <c:strRef>
              <c:f>'WCS HFU OR V NOR'!$C$1:$C$2</c:f>
              <c:strCache>
                <c:ptCount val="2"/>
                <c:pt idx="0">
                  <c:v>Case 1</c:v>
                </c:pt>
                <c:pt idx="1">
                  <c:v>I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WCS HFU OR V NOR'!$A$3:$A$20</c:f>
              <c:strCache>
                <c:ptCount val="18"/>
                <c:pt idx="0">
                  <c:v>CTV D95 (%)</c:v>
                </c:pt>
                <c:pt idx="1">
                  <c:v>Lung V5 (%)</c:v>
                </c:pt>
                <c:pt idx="2">
                  <c:v>Lung V10 (%)</c:v>
                </c:pt>
                <c:pt idx="3">
                  <c:v>Lung V20 (%)</c:v>
                </c:pt>
                <c:pt idx="4">
                  <c:v>Mean lung Dose (Gy)</c:v>
                </c:pt>
                <c:pt idx="5">
                  <c:v>Contralateral lung V5 (Gy)</c:v>
                </c:pt>
                <c:pt idx="6">
                  <c:v>Contralateral lung V10 (Gy)</c:v>
                </c:pt>
                <c:pt idx="7">
                  <c:v>Contralateral lung V20 (Gy)</c:v>
                </c:pt>
                <c:pt idx="8">
                  <c:v>Heart V5 (%)</c:v>
                </c:pt>
                <c:pt idx="9">
                  <c:v>Heart V10 (%)</c:v>
                </c:pt>
                <c:pt idx="10">
                  <c:v>Heart V20 (%)</c:v>
                </c:pt>
                <c:pt idx="11">
                  <c:v>Heart V30 (%)</c:v>
                </c:pt>
                <c:pt idx="12">
                  <c:v>Heart V40 (%)</c:v>
                </c:pt>
                <c:pt idx="13">
                  <c:v>Mean heart dose (Gy)</c:v>
                </c:pt>
                <c:pt idx="14">
                  <c:v>Oesophagus V35 (%)</c:v>
                </c:pt>
                <c:pt idx="15">
                  <c:v>SC Dmax (Gy) (1cc)  </c:v>
                </c:pt>
                <c:pt idx="16">
                  <c:v>BP Dmax (Gy) (1cc)</c:v>
                </c:pt>
                <c:pt idx="17">
                  <c:v>Mean TV dose (Gy)</c:v>
                </c:pt>
              </c:strCache>
            </c:strRef>
          </c:cat>
          <c:val>
            <c:numRef>
              <c:f>'WCS HFU OR V NOR'!$C$3:$C$20</c:f>
              <c:numCache>
                <c:formatCode>0.0</c:formatCode>
                <c:ptCount val="18"/>
                <c:pt idx="0" formatCode="0.00">
                  <c:v>90.47</c:v>
                </c:pt>
                <c:pt idx="1">
                  <c:v>21.14</c:v>
                </c:pt>
                <c:pt idx="2">
                  <c:v>18.59</c:v>
                </c:pt>
                <c:pt idx="3">
                  <c:v>15.12</c:v>
                </c:pt>
                <c:pt idx="4">
                  <c:v>6.73</c:v>
                </c:pt>
                <c:pt idx="5">
                  <c:v>0.19</c:v>
                </c:pt>
                <c:pt idx="6">
                  <c:v>0</c:v>
                </c:pt>
                <c:pt idx="7">
                  <c:v>0</c:v>
                </c:pt>
                <c:pt idx="8">
                  <c:v>15.75</c:v>
                </c:pt>
                <c:pt idx="9">
                  <c:v>12.72</c:v>
                </c:pt>
                <c:pt idx="10">
                  <c:v>9.39</c:v>
                </c:pt>
                <c:pt idx="11">
                  <c:v>7.22</c:v>
                </c:pt>
                <c:pt idx="12">
                  <c:v>5.46</c:v>
                </c:pt>
                <c:pt idx="13">
                  <c:v>3.66</c:v>
                </c:pt>
                <c:pt idx="14">
                  <c:v>13.31</c:v>
                </c:pt>
                <c:pt idx="15">
                  <c:v>45</c:v>
                </c:pt>
                <c:pt idx="16">
                  <c:v>64.790000000000006</c:v>
                </c:pt>
                <c:pt idx="17">
                  <c:v>7.44</c:v>
                </c:pt>
              </c:numCache>
            </c:numRef>
          </c:val>
        </c:ser>
        <c:ser>
          <c:idx val="2"/>
          <c:order val="2"/>
          <c:tx>
            <c:strRef>
              <c:f>'WCS HFU OR V NOR'!$D$1:$D$2</c:f>
              <c:strCache>
                <c:ptCount val="2"/>
                <c:pt idx="0">
                  <c:v>Case 2</c:v>
                </c:pt>
                <c:pt idx="1">
                  <c:v>No IC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WCS HFU OR V NOR'!$A$3:$A$20</c:f>
              <c:strCache>
                <c:ptCount val="18"/>
                <c:pt idx="0">
                  <c:v>CTV D95 (%)</c:v>
                </c:pt>
                <c:pt idx="1">
                  <c:v>Lung V5 (%)</c:v>
                </c:pt>
                <c:pt idx="2">
                  <c:v>Lung V10 (%)</c:v>
                </c:pt>
                <c:pt idx="3">
                  <c:v>Lung V20 (%)</c:v>
                </c:pt>
                <c:pt idx="4">
                  <c:v>Mean lung Dose (Gy)</c:v>
                </c:pt>
                <c:pt idx="5">
                  <c:v>Contralateral lung V5 (Gy)</c:v>
                </c:pt>
                <c:pt idx="6">
                  <c:v>Contralateral lung V10 (Gy)</c:v>
                </c:pt>
                <c:pt idx="7">
                  <c:v>Contralateral lung V20 (Gy)</c:v>
                </c:pt>
                <c:pt idx="8">
                  <c:v>Heart V5 (%)</c:v>
                </c:pt>
                <c:pt idx="9">
                  <c:v>Heart V10 (%)</c:v>
                </c:pt>
                <c:pt idx="10">
                  <c:v>Heart V20 (%)</c:v>
                </c:pt>
                <c:pt idx="11">
                  <c:v>Heart V30 (%)</c:v>
                </c:pt>
                <c:pt idx="12">
                  <c:v>Heart V40 (%)</c:v>
                </c:pt>
                <c:pt idx="13">
                  <c:v>Mean heart dose (Gy)</c:v>
                </c:pt>
                <c:pt idx="14">
                  <c:v>Oesophagus V35 (%)</c:v>
                </c:pt>
                <c:pt idx="15">
                  <c:v>SC Dmax (Gy) (1cc)  </c:v>
                </c:pt>
                <c:pt idx="16">
                  <c:v>BP Dmax (Gy) (1cc)</c:v>
                </c:pt>
                <c:pt idx="17">
                  <c:v>Mean TV dose (Gy)</c:v>
                </c:pt>
              </c:strCache>
            </c:strRef>
          </c:cat>
          <c:val>
            <c:numRef>
              <c:f>'WCS HFU OR V NOR'!$D$3:$D$20</c:f>
              <c:numCache>
                <c:formatCode>0.00</c:formatCode>
                <c:ptCount val="18"/>
                <c:pt idx="0">
                  <c:v>95.33</c:v>
                </c:pt>
                <c:pt idx="1">
                  <c:v>34.28</c:v>
                </c:pt>
                <c:pt idx="2" formatCode="General">
                  <c:v>30.67</c:v>
                </c:pt>
                <c:pt idx="3">
                  <c:v>25.55</c:v>
                </c:pt>
                <c:pt idx="4">
                  <c:v>11.14</c:v>
                </c:pt>
                <c:pt idx="5">
                  <c:v>9.6999999999999993</c:v>
                </c:pt>
                <c:pt idx="6">
                  <c:v>6.45</c:v>
                </c:pt>
                <c:pt idx="7">
                  <c:v>2.5099999999999998</c:v>
                </c:pt>
                <c:pt idx="8">
                  <c:v>26.47</c:v>
                </c:pt>
                <c:pt idx="9">
                  <c:v>23.31</c:v>
                </c:pt>
                <c:pt idx="10">
                  <c:v>19.27</c:v>
                </c:pt>
                <c:pt idx="11">
                  <c:v>16.07</c:v>
                </c:pt>
                <c:pt idx="12">
                  <c:v>13.26</c:v>
                </c:pt>
                <c:pt idx="13">
                  <c:v>7.75</c:v>
                </c:pt>
                <c:pt idx="14" formatCode="General">
                  <c:v>44.59</c:v>
                </c:pt>
                <c:pt idx="15">
                  <c:v>51.59</c:v>
                </c:pt>
                <c:pt idx="16">
                  <c:v>65.569999999999993</c:v>
                </c:pt>
                <c:pt idx="17" formatCode="General">
                  <c:v>14.13</c:v>
                </c:pt>
              </c:numCache>
            </c:numRef>
          </c:val>
        </c:ser>
        <c:ser>
          <c:idx val="3"/>
          <c:order val="3"/>
          <c:tx>
            <c:strRef>
              <c:f>'WCS HFU OR V NOR'!$E$1:$E$2</c:f>
              <c:strCache>
                <c:ptCount val="2"/>
                <c:pt idx="0">
                  <c:v>Case 2</c:v>
                </c:pt>
                <c:pt idx="1">
                  <c:v>IC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WCS HFU OR V NOR'!$A$3:$A$20</c:f>
              <c:strCache>
                <c:ptCount val="18"/>
                <c:pt idx="0">
                  <c:v>CTV D95 (%)</c:v>
                </c:pt>
                <c:pt idx="1">
                  <c:v>Lung V5 (%)</c:v>
                </c:pt>
                <c:pt idx="2">
                  <c:v>Lung V10 (%)</c:v>
                </c:pt>
                <c:pt idx="3">
                  <c:v>Lung V20 (%)</c:v>
                </c:pt>
                <c:pt idx="4">
                  <c:v>Mean lung Dose (Gy)</c:v>
                </c:pt>
                <c:pt idx="5">
                  <c:v>Contralateral lung V5 (Gy)</c:v>
                </c:pt>
                <c:pt idx="6">
                  <c:v>Contralateral lung V10 (Gy)</c:v>
                </c:pt>
                <c:pt idx="7">
                  <c:v>Contralateral lung V20 (Gy)</c:v>
                </c:pt>
                <c:pt idx="8">
                  <c:v>Heart V5 (%)</c:v>
                </c:pt>
                <c:pt idx="9">
                  <c:v>Heart V10 (%)</c:v>
                </c:pt>
                <c:pt idx="10">
                  <c:v>Heart V20 (%)</c:v>
                </c:pt>
                <c:pt idx="11">
                  <c:v>Heart V30 (%)</c:v>
                </c:pt>
                <c:pt idx="12">
                  <c:v>Heart V40 (%)</c:v>
                </c:pt>
                <c:pt idx="13">
                  <c:v>Mean heart dose (Gy)</c:v>
                </c:pt>
                <c:pt idx="14">
                  <c:v>Oesophagus V35 (%)</c:v>
                </c:pt>
                <c:pt idx="15">
                  <c:v>SC Dmax (Gy) (1cc)  </c:v>
                </c:pt>
                <c:pt idx="16">
                  <c:v>BP Dmax (Gy) (1cc)</c:v>
                </c:pt>
                <c:pt idx="17">
                  <c:v>Mean TV dose (Gy)</c:v>
                </c:pt>
              </c:strCache>
            </c:strRef>
          </c:cat>
          <c:val>
            <c:numRef>
              <c:f>'WCS HFU OR V NOR'!$E$3:$E$20</c:f>
              <c:numCache>
                <c:formatCode>General</c:formatCode>
                <c:ptCount val="18"/>
                <c:pt idx="0" formatCode="0.00">
                  <c:v>95.32</c:v>
                </c:pt>
                <c:pt idx="1">
                  <c:v>34.29</c:v>
                </c:pt>
                <c:pt idx="2">
                  <c:v>30.67</c:v>
                </c:pt>
                <c:pt idx="3">
                  <c:v>25.55</c:v>
                </c:pt>
                <c:pt idx="4">
                  <c:v>11.14</c:v>
                </c:pt>
                <c:pt idx="5">
                  <c:v>9.86</c:v>
                </c:pt>
                <c:pt idx="6">
                  <c:v>6.45</c:v>
                </c:pt>
                <c:pt idx="7">
                  <c:v>2.5099999999999998</c:v>
                </c:pt>
                <c:pt idx="8">
                  <c:v>26.46</c:v>
                </c:pt>
                <c:pt idx="9">
                  <c:v>23.31</c:v>
                </c:pt>
                <c:pt idx="10">
                  <c:v>19.27</c:v>
                </c:pt>
                <c:pt idx="11">
                  <c:v>16.059999999999999</c:v>
                </c:pt>
                <c:pt idx="12">
                  <c:v>13.26</c:v>
                </c:pt>
                <c:pt idx="13">
                  <c:v>7.75</c:v>
                </c:pt>
                <c:pt idx="14">
                  <c:v>44.59</c:v>
                </c:pt>
                <c:pt idx="15">
                  <c:v>51.57</c:v>
                </c:pt>
                <c:pt idx="16">
                  <c:v>65.569999999999993</c:v>
                </c:pt>
                <c:pt idx="17">
                  <c:v>14.14</c:v>
                </c:pt>
              </c:numCache>
            </c:numRef>
          </c:val>
        </c:ser>
        <c:ser>
          <c:idx val="4"/>
          <c:order val="4"/>
          <c:tx>
            <c:strRef>
              <c:f>'WCS HFU OR V NOR'!$F$1:$F$2</c:f>
              <c:strCache>
                <c:ptCount val="2"/>
                <c:pt idx="0">
                  <c:v>Case 3</c:v>
                </c:pt>
                <c:pt idx="1">
                  <c:v>No IC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WCS HFU OR V NOR'!$A$3:$A$20</c:f>
              <c:strCache>
                <c:ptCount val="18"/>
                <c:pt idx="0">
                  <c:v>CTV D95 (%)</c:v>
                </c:pt>
                <c:pt idx="1">
                  <c:v>Lung V5 (%)</c:v>
                </c:pt>
                <c:pt idx="2">
                  <c:v>Lung V10 (%)</c:v>
                </c:pt>
                <c:pt idx="3">
                  <c:v>Lung V20 (%)</c:v>
                </c:pt>
                <c:pt idx="4">
                  <c:v>Mean lung Dose (Gy)</c:v>
                </c:pt>
                <c:pt idx="5">
                  <c:v>Contralateral lung V5 (Gy)</c:v>
                </c:pt>
                <c:pt idx="6">
                  <c:v>Contralateral lung V10 (Gy)</c:v>
                </c:pt>
                <c:pt idx="7">
                  <c:v>Contralateral lung V20 (Gy)</c:v>
                </c:pt>
                <c:pt idx="8">
                  <c:v>Heart V5 (%)</c:v>
                </c:pt>
                <c:pt idx="9">
                  <c:v>Heart V10 (%)</c:v>
                </c:pt>
                <c:pt idx="10">
                  <c:v>Heart V20 (%)</c:v>
                </c:pt>
                <c:pt idx="11">
                  <c:v>Heart V30 (%)</c:v>
                </c:pt>
                <c:pt idx="12">
                  <c:v>Heart V40 (%)</c:v>
                </c:pt>
                <c:pt idx="13">
                  <c:v>Mean heart dose (Gy)</c:v>
                </c:pt>
                <c:pt idx="14">
                  <c:v>Oesophagus V35 (%)</c:v>
                </c:pt>
                <c:pt idx="15">
                  <c:v>SC Dmax (Gy) (1cc)  </c:v>
                </c:pt>
                <c:pt idx="16">
                  <c:v>BP Dmax (Gy) (1cc)</c:v>
                </c:pt>
                <c:pt idx="17">
                  <c:v>Mean TV dose (Gy)</c:v>
                </c:pt>
              </c:strCache>
            </c:strRef>
          </c:cat>
          <c:val>
            <c:numRef>
              <c:f>'WCS HFU OR V NOR'!$F$3:$F$20</c:f>
              <c:numCache>
                <c:formatCode>0.00</c:formatCode>
                <c:ptCount val="18"/>
                <c:pt idx="0">
                  <c:v>97.78</c:v>
                </c:pt>
                <c:pt idx="1">
                  <c:v>36.65</c:v>
                </c:pt>
                <c:pt idx="2" formatCode="General">
                  <c:v>30.46</c:v>
                </c:pt>
                <c:pt idx="3">
                  <c:v>21.71</c:v>
                </c:pt>
                <c:pt idx="4">
                  <c:v>11.4</c:v>
                </c:pt>
                <c:pt idx="5">
                  <c:v>25.97</c:v>
                </c:pt>
                <c:pt idx="6">
                  <c:v>18.579999999999998</c:v>
                </c:pt>
                <c:pt idx="7">
                  <c:v>8.07</c:v>
                </c:pt>
                <c:pt idx="8">
                  <c:v>44.07</c:v>
                </c:pt>
                <c:pt idx="9">
                  <c:v>38.6</c:v>
                </c:pt>
                <c:pt idx="10">
                  <c:v>32.049999999999997</c:v>
                </c:pt>
                <c:pt idx="11">
                  <c:v>27.18</c:v>
                </c:pt>
                <c:pt idx="12">
                  <c:v>22.67</c:v>
                </c:pt>
                <c:pt idx="13">
                  <c:v>13.95</c:v>
                </c:pt>
                <c:pt idx="14" formatCode="General">
                  <c:v>47.22</c:v>
                </c:pt>
                <c:pt idx="15">
                  <c:v>39.020000000000003</c:v>
                </c:pt>
                <c:pt idx="16">
                  <c:v>65.180000000000007</c:v>
                </c:pt>
                <c:pt idx="17" formatCode="General">
                  <c:v>11.16</c:v>
                </c:pt>
              </c:numCache>
            </c:numRef>
          </c:val>
        </c:ser>
        <c:ser>
          <c:idx val="5"/>
          <c:order val="5"/>
          <c:tx>
            <c:strRef>
              <c:f>'WCS HFU OR V NOR'!$G$1:$G$2</c:f>
              <c:strCache>
                <c:ptCount val="2"/>
                <c:pt idx="0">
                  <c:v>Case 3</c:v>
                </c:pt>
                <c:pt idx="1">
                  <c:v>IC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WCS HFU OR V NOR'!$A$3:$A$20</c:f>
              <c:strCache>
                <c:ptCount val="18"/>
                <c:pt idx="0">
                  <c:v>CTV D95 (%)</c:v>
                </c:pt>
                <c:pt idx="1">
                  <c:v>Lung V5 (%)</c:v>
                </c:pt>
                <c:pt idx="2">
                  <c:v>Lung V10 (%)</c:v>
                </c:pt>
                <c:pt idx="3">
                  <c:v>Lung V20 (%)</c:v>
                </c:pt>
                <c:pt idx="4">
                  <c:v>Mean lung Dose (Gy)</c:v>
                </c:pt>
                <c:pt idx="5">
                  <c:v>Contralateral lung V5 (Gy)</c:v>
                </c:pt>
                <c:pt idx="6">
                  <c:v>Contralateral lung V10 (Gy)</c:v>
                </c:pt>
                <c:pt idx="7">
                  <c:v>Contralateral lung V20 (Gy)</c:v>
                </c:pt>
                <c:pt idx="8">
                  <c:v>Heart V5 (%)</c:v>
                </c:pt>
                <c:pt idx="9">
                  <c:v>Heart V10 (%)</c:v>
                </c:pt>
                <c:pt idx="10">
                  <c:v>Heart V20 (%)</c:v>
                </c:pt>
                <c:pt idx="11">
                  <c:v>Heart V30 (%)</c:v>
                </c:pt>
                <c:pt idx="12">
                  <c:v>Heart V40 (%)</c:v>
                </c:pt>
                <c:pt idx="13">
                  <c:v>Mean heart dose (Gy)</c:v>
                </c:pt>
                <c:pt idx="14">
                  <c:v>Oesophagus V35 (%)</c:v>
                </c:pt>
                <c:pt idx="15">
                  <c:v>SC Dmax (Gy) (1cc)  </c:v>
                </c:pt>
                <c:pt idx="16">
                  <c:v>BP Dmax (Gy) (1cc)</c:v>
                </c:pt>
                <c:pt idx="17">
                  <c:v>Mean TV dose (Gy)</c:v>
                </c:pt>
              </c:strCache>
            </c:strRef>
          </c:cat>
          <c:val>
            <c:numRef>
              <c:f>'WCS HFU OR V NOR'!$G$3:$G$20</c:f>
              <c:numCache>
                <c:formatCode>0.0</c:formatCode>
                <c:ptCount val="18"/>
                <c:pt idx="0" formatCode="0.00">
                  <c:v>97.13</c:v>
                </c:pt>
                <c:pt idx="1">
                  <c:v>36.64</c:v>
                </c:pt>
                <c:pt idx="2">
                  <c:v>30.46</c:v>
                </c:pt>
                <c:pt idx="3">
                  <c:v>21.7</c:v>
                </c:pt>
                <c:pt idx="4">
                  <c:v>11.37</c:v>
                </c:pt>
                <c:pt idx="5">
                  <c:v>25.97</c:v>
                </c:pt>
                <c:pt idx="6">
                  <c:v>18.559999999999999</c:v>
                </c:pt>
                <c:pt idx="7">
                  <c:v>8.06</c:v>
                </c:pt>
                <c:pt idx="8">
                  <c:v>44.05</c:v>
                </c:pt>
                <c:pt idx="9">
                  <c:v>38.6</c:v>
                </c:pt>
                <c:pt idx="10">
                  <c:v>32.049999999999997</c:v>
                </c:pt>
                <c:pt idx="11">
                  <c:v>27.15</c:v>
                </c:pt>
                <c:pt idx="12">
                  <c:v>22.61</c:v>
                </c:pt>
                <c:pt idx="13">
                  <c:v>13.9</c:v>
                </c:pt>
                <c:pt idx="14">
                  <c:v>47.21</c:v>
                </c:pt>
                <c:pt idx="15">
                  <c:v>38.299999999999997</c:v>
                </c:pt>
                <c:pt idx="16">
                  <c:v>65.23</c:v>
                </c:pt>
                <c:pt idx="17">
                  <c:v>11.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6474744"/>
        <c:axId val="396476312"/>
      </c:barChart>
      <c:catAx>
        <c:axId val="396474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6476312"/>
        <c:crosses val="autoZero"/>
        <c:auto val="1"/>
        <c:lblAlgn val="ctr"/>
        <c:lblOffset val="100"/>
        <c:noMultiLvlLbl val="0"/>
      </c:catAx>
      <c:valAx>
        <c:axId val="39647631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6474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2143985126859143"/>
          <c:y val="0.12026465441819773"/>
          <c:w val="0.16189348206474191"/>
          <c:h val="0.468753280839895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940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961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390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164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5296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121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305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4351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9627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69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5962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6D9AB-B7BB-4EFA-9721-66EAB15B3A0B}" type="datetimeFigureOut">
              <a:rPr lang="en-GB" smtClean="0"/>
              <a:t>2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553EE-E34D-4736-BCB3-CD159B4D2B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30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6611" y="6170575"/>
            <a:ext cx="646006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Supplementary fig 1. </a:t>
            </a:r>
            <a:r>
              <a:rPr lang="en-GB" sz="1000" dirty="0"/>
              <a:t>Graph</a:t>
            </a:r>
            <a:r>
              <a:rPr lang="en-GB" sz="1000" b="1" dirty="0"/>
              <a:t> </a:t>
            </a:r>
            <a:r>
              <a:rPr lang="en-GB" sz="1000" dirty="0"/>
              <a:t>showing the worst case scenario doses to the target and OARs for the nominal PBS plans </a:t>
            </a:r>
            <a:r>
              <a:rPr lang="en-GB" sz="1000" dirty="0" smtClean="0"/>
              <a:t>with (IC) </a:t>
            </a:r>
            <a:r>
              <a:rPr lang="en-GB" sz="1000" dirty="0"/>
              <a:t>and </a:t>
            </a:r>
            <a:r>
              <a:rPr lang="en-GB" sz="1000" dirty="0" smtClean="0"/>
              <a:t>without inhomogeneity correction </a:t>
            </a:r>
            <a:r>
              <a:rPr lang="en-GB" sz="1000" dirty="0" smtClean="0"/>
              <a:t>(No IC</a:t>
            </a:r>
            <a:r>
              <a:rPr lang="en-GB" sz="1000" dirty="0" smtClean="0"/>
              <a:t>). </a:t>
            </a:r>
            <a:r>
              <a:rPr lang="en-GB" sz="1000" dirty="0"/>
              <a:t>CTV (clinical target volume). TV (thoracic vertebra). BP (brachial plexus). SC (spinal canal). 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190054"/>
              </p:ext>
            </p:extLst>
          </p:nvPr>
        </p:nvGraphicFramePr>
        <p:xfrm>
          <a:off x="236611" y="2015066"/>
          <a:ext cx="6460066" cy="41555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32989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54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wee-Ling Wong</dc:creator>
  <cp:lastModifiedBy>Swee-Ling Wong</cp:lastModifiedBy>
  <cp:revision>6</cp:revision>
  <cp:lastPrinted>2020-02-27T09:03:10Z</cp:lastPrinted>
  <dcterms:created xsi:type="dcterms:W3CDTF">2020-02-04T16:48:06Z</dcterms:created>
  <dcterms:modified xsi:type="dcterms:W3CDTF">2020-02-27T10:14:18Z</dcterms:modified>
</cp:coreProperties>
</file>